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em\Dropbox\&#12450;&#12531;&#12465;&#12540;&#12488;&#35519;&#26619;\1067693_&#21152;&#24037;&#24460;_GT&#35299;&#26512;&#36861;&#2115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em\Dropbox\&#12450;&#12531;&#12465;&#12540;&#12488;&#35519;&#26619;\1067693_&#21152;&#24037;&#24460;_GT&#35299;&#26512;&#36861;&#2115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em\Dropbox\&#12450;&#12531;&#12465;&#12540;&#12488;&#35519;&#26619;\1067693_&#21152;&#24037;&#24460;_GT&#35299;&#26512;&#36861;&#21152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em\Dropbox\&#12450;&#12531;&#12465;&#12540;&#12488;&#35519;&#26619;\1067693_&#21152;&#24037;&#24460;_GT&#35299;&#26512;&#36861;&#21152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em\Dropbox\&#12450;&#12531;&#12465;&#12540;&#12488;&#35519;&#26619;\1067693_&#21152;&#24037;&#24460;_GT&#35299;&#26512;&#36861;&#2115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468763670166225"/>
          <c:y val="0.28473934013730406"/>
          <c:w val="0.31062472659667539"/>
          <c:h val="0.5392960875981565"/>
        </c:manualLayout>
      </c:layout>
      <c:pieChart>
        <c:varyColors val="1"/>
        <c:ser>
          <c:idx val="0"/>
          <c:order val="0"/>
          <c:spPr>
            <a:ln w="12700">
              <a:solidFill>
                <a:srgbClr val="BFBFBF"/>
              </a:solidFill>
            </a:ln>
          </c:spPr>
          <c:dPt>
            <c:idx val="0"/>
            <c:bubble3D val="0"/>
            <c:spPr>
              <a:solidFill>
                <a:srgbClr val="95B3D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109-4F20-8FF4-6681F201A2D7}"/>
              </c:ext>
            </c:extLst>
          </c:dPt>
          <c:dPt>
            <c:idx val="1"/>
            <c:bubble3D val="0"/>
            <c:spPr>
              <a:solidFill>
                <a:srgbClr val="DA969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109-4F20-8FF4-6681F201A2D7}"/>
              </c:ext>
            </c:extLst>
          </c:dPt>
          <c:dPt>
            <c:idx val="2"/>
            <c:bubble3D val="0"/>
            <c:spPr>
              <a:solidFill>
                <a:srgbClr val="C4D79B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1109-4F20-8FF4-6681F201A2D7}"/>
              </c:ext>
            </c:extLst>
          </c:dPt>
          <c:dPt>
            <c:idx val="3"/>
            <c:bubble3D val="0"/>
            <c:spPr>
              <a:solidFill>
                <a:srgbClr val="FABF8F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1109-4F20-8FF4-6681F201A2D7}"/>
              </c:ext>
            </c:extLst>
          </c:dPt>
          <c:dPt>
            <c:idx val="4"/>
            <c:bubble3D val="0"/>
            <c:spPr>
              <a:solidFill>
                <a:srgbClr val="92CDD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1109-4F20-8FF4-6681F201A2D7}"/>
              </c:ext>
            </c:extLst>
          </c:dPt>
          <c:dPt>
            <c:idx val="5"/>
            <c:bubble3D val="0"/>
            <c:spPr>
              <a:solidFill>
                <a:srgbClr val="B1A0C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1109-4F20-8FF4-6681F201A2D7}"/>
              </c:ext>
            </c:extLst>
          </c:dPt>
          <c:dPt>
            <c:idx val="6"/>
            <c:bubble3D val="0"/>
            <c:spPr>
              <a:solidFill>
                <a:srgbClr val="538DD5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1109-4F20-8FF4-6681F201A2D7}"/>
              </c:ext>
            </c:extLst>
          </c:dPt>
          <c:dPt>
            <c:idx val="7"/>
            <c:bubble3D val="0"/>
            <c:spPr>
              <a:solidFill>
                <a:srgbClr val="B8CCE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1109-4F20-8FF4-6681F201A2D7}"/>
              </c:ext>
            </c:extLst>
          </c:dPt>
          <c:dPt>
            <c:idx val="8"/>
            <c:bubble3D val="0"/>
            <c:spPr>
              <a:solidFill>
                <a:srgbClr val="E6B8B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1109-4F20-8FF4-6681F201A2D7}"/>
              </c:ext>
            </c:extLst>
          </c:dPt>
          <c:dPt>
            <c:idx val="9"/>
            <c:bubble3D val="0"/>
            <c:spPr>
              <a:solidFill>
                <a:srgbClr val="D8E4B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1109-4F20-8FF4-6681F201A2D7}"/>
              </c:ext>
            </c:extLst>
          </c:dPt>
          <c:dPt>
            <c:idx val="10"/>
            <c:bubble3D val="0"/>
            <c:spPr>
              <a:solidFill>
                <a:srgbClr val="FCD5B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1109-4F20-8FF4-6681F201A2D7}"/>
              </c:ext>
            </c:extLst>
          </c:dPt>
          <c:dPt>
            <c:idx val="11"/>
            <c:bubble3D val="0"/>
            <c:spPr>
              <a:solidFill>
                <a:srgbClr val="B7DEE8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1109-4F20-8FF4-6681F201A2D7}"/>
              </c:ext>
            </c:extLst>
          </c:dPt>
          <c:dLbls>
            <c:dLbl>
              <c:idx val="0"/>
              <c:layout>
                <c:manualLayout>
                  <c:x val="-8.8717942135760119E-2"/>
                  <c:y val="-3.8484507820203982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baseline="0" dirty="0"/>
                      <a:t>MALE/20-29 </a:t>
                    </a:r>
                    <a:r>
                      <a:rPr lang="en-US" altLang="zh-CN" baseline="0" dirty="0" err="1"/>
                      <a:t>y.o</a:t>
                    </a:r>
                    <a:r>
                      <a:rPr lang="en-US" altLang="zh-CN" baseline="0" dirty="0"/>
                      <a:t>.</a:t>
                    </a:r>
                  </a:p>
                  <a:p>
                    <a:r>
                      <a:rPr lang="en-US" altLang="zh-CN" baseline="0" dirty="0"/>
                      <a:t> </a:t>
                    </a:r>
                    <a:fld id="{991BC3E5-2312-4C50-AF9A-8917108DBFAD}" type="VALUE">
                      <a:rPr lang="en-US" altLang="zh-CN" baseline="0"/>
                      <a:pPr/>
                      <a:t>[値]</a:t>
                    </a:fld>
                    <a:endParaRPr lang="en-US" altLang="zh-CN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46122109034174613"/>
                      <c:h val="0.1432254284573040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109-4F20-8FF4-6681F201A2D7}"/>
                </c:ext>
              </c:extLst>
            </c:dLbl>
            <c:dLbl>
              <c:idx val="1"/>
              <c:layout>
                <c:manualLayout>
                  <c:x val="1.4261408770481165E-7"/>
                  <c:y val="4.532582102779819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baseline="0" dirty="0"/>
                      <a:t>MALE/30-39 </a:t>
                    </a:r>
                    <a:r>
                      <a:rPr lang="en-US" altLang="zh-CN" baseline="0" dirty="0" err="1"/>
                      <a:t>y.o</a:t>
                    </a:r>
                    <a:r>
                      <a:rPr lang="en-US" altLang="zh-CN" baseline="0" dirty="0"/>
                      <a:t>. </a:t>
                    </a:r>
                    <a:fld id="{E3CC4D2C-8ED4-41F0-81B0-CDA81C4255CE}" type="VALUE">
                      <a:rPr lang="en-US" altLang="zh-CN" baseline="0" smtClean="0"/>
                      <a:pPr/>
                      <a:t>[値]</a:t>
                    </a:fld>
                    <a:endParaRPr lang="en-US" altLang="zh-CN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0518302378945589"/>
                      <c:h val="0.14385929874052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1109-4F20-8FF4-6681F201A2D7}"/>
                </c:ext>
              </c:extLst>
            </c:dLbl>
            <c:dLbl>
              <c:idx val="2"/>
              <c:layout>
                <c:manualLayout>
                  <c:x val="3.9140336249011143E-2"/>
                  <c:y val="2.8649667299915277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MALE/40-49 y.o.</a:t>
                    </a:r>
                    <a:r>
                      <a:rPr lang="en-US" altLang="zh-CN" baseline="0"/>
                      <a:t> </a:t>
                    </a:r>
                    <a:fld id="{4DA7B642-D0EA-4A1F-8CB7-749E4C83EF08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966293160370968"/>
                      <c:h val="0.1447159012894286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1109-4F20-8FF4-6681F201A2D7}"/>
                </c:ext>
              </c:extLst>
            </c:dLbl>
            <c:dLbl>
              <c:idx val="3"/>
              <c:layout>
                <c:manualLayout>
                  <c:x val="7.627021176122753E-2"/>
                  <c:y val="1.554317797376664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/>
                      <a:t>MALE/50-59 </a:t>
                    </a:r>
                    <a:r>
                      <a:rPr lang="en-US" altLang="zh-CN" dirty="0" err="1"/>
                      <a:t>y.o</a:t>
                    </a:r>
                    <a:r>
                      <a:rPr lang="en-US" altLang="zh-CN" dirty="0"/>
                      <a:t>.</a:t>
                    </a:r>
                    <a:r>
                      <a:rPr lang="en-US" altLang="zh-CN" baseline="0" dirty="0"/>
                      <a:t> </a:t>
                    </a:r>
                    <a:fld id="{378E2FA9-1A4D-4E8D-AF82-48360C6B8EBC}" type="VALUE">
                      <a:rPr lang="en-US" altLang="zh-CN" baseline="0"/>
                      <a:pPr/>
                      <a:t>[値]</a:t>
                    </a:fld>
                    <a:endParaRPr lang="en-US" altLang="zh-CN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7856210772212503"/>
                      <c:h val="0.1447159012894286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1109-4F20-8FF4-6681F201A2D7}"/>
                </c:ext>
              </c:extLst>
            </c:dLbl>
            <c:dLbl>
              <c:idx val="4"/>
              <c:layout>
                <c:manualLayout>
                  <c:x val="2.4077302183291367E-3"/>
                  <c:y val="5.1875026789715666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MALE/60-69 y.o.</a:t>
                    </a:r>
                    <a:r>
                      <a:rPr lang="en-US" altLang="zh-CN" baseline="0"/>
                      <a:t> </a:t>
                    </a:r>
                    <a:fld id="{2C7B259E-5E01-4FAC-839A-BCF560AF65AA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1421192168204753"/>
                      <c:h val="0.1444143740716238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1109-4F20-8FF4-6681F201A2D7}"/>
                </c:ext>
              </c:extLst>
            </c:dLbl>
            <c:dLbl>
              <c:idx val="5"/>
              <c:layout>
                <c:manualLayout>
                  <c:x val="-1.5959429744471024E-3"/>
                  <c:y val="4.723213520738678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MALE/70-79 y.o.</a:t>
                    </a:r>
                    <a:r>
                      <a:rPr lang="en-US" altLang="zh-CN" baseline="0"/>
                      <a:t> </a:t>
                    </a:r>
                    <a:fld id="{03C8B218-48BB-4505-8079-9E104D7101C5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4185894611041467"/>
                      <c:h val="0.1496694512750739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1109-4F20-8FF4-6681F201A2D7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 altLang="zh-CN"/>
                      <a:t>FEMALE/20-29 y.o.</a:t>
                    </a:r>
                    <a:r>
                      <a:rPr lang="en-US" altLang="zh-CN" baseline="0"/>
                      <a:t> </a:t>
                    </a:r>
                    <a:fld id="{8E79871E-0589-4F67-9103-C519D2A46FB2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1109-4F20-8FF4-6681F201A2D7}"/>
                </c:ext>
              </c:extLst>
            </c:dLbl>
            <c:dLbl>
              <c:idx val="7"/>
              <c:layout>
                <c:manualLayout>
                  <c:x val="-4.7091171760128808E-2"/>
                  <c:y val="2.336543382472258E-4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FEMALE/30-39 y.o.</a:t>
                    </a:r>
                    <a:r>
                      <a:rPr lang="en-US" altLang="zh-CN" baseline="0"/>
                      <a:t> </a:t>
                    </a:r>
                    <a:fld id="{02ED9AF3-2C73-4579-8416-0079B0198E28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2023137709589228"/>
                      <c:h val="0.1444143740716238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1109-4F20-8FF4-6681F201A2D7}"/>
                </c:ext>
              </c:extLst>
            </c:dLbl>
            <c:dLbl>
              <c:idx val="8"/>
              <c:layout>
                <c:manualLayout>
                  <c:x val="0"/>
                  <c:y val="1.2639178410495175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FEMALE/40-49 y.o.</a:t>
                    </a:r>
                    <a:r>
                      <a:rPr lang="en-US" altLang="zh-CN" baseline="0"/>
                      <a:t> </a:t>
                    </a:r>
                    <a:fld id="{E0B8AB22-9AE2-45DB-8550-76FFDF8B0194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3326060014860387"/>
                      <c:h val="0.18948820728221388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1109-4F20-8FF4-6681F201A2D7}"/>
                </c:ext>
              </c:extLst>
            </c:dLbl>
            <c:dLbl>
              <c:idx val="9"/>
              <c:layout>
                <c:manualLayout>
                  <c:x val="-6.5284542105636945E-8"/>
                  <c:y val="4.2895161248192197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FEMALE/50-59 y.o.</a:t>
                    </a:r>
                    <a:r>
                      <a:rPr lang="en-US" altLang="zh-CN" baseline="0"/>
                      <a:t> </a:t>
                    </a:r>
                    <a:fld id="{5D1CB2CA-D701-472F-8C54-024E482FBEF1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4190101726628758"/>
                      <c:h val="0.1444143740716238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1109-4F20-8FF4-6681F201A2D7}"/>
                </c:ext>
              </c:extLst>
            </c:dLbl>
            <c:dLbl>
              <c:idx val="10"/>
              <c:layout>
                <c:manualLayout>
                  <c:x val="-4.3612459246676644E-2"/>
                  <c:y val="-8.4481644268640452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baseline="0"/>
                      <a:t>FEMALE/60-69 y.o. </a:t>
                    </a:r>
                    <a:fld id="{5B7EAFB7-3D7C-4F48-9FAE-FE44066096E5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6615325595092937"/>
                      <c:h val="0.1447155112154082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1109-4F20-8FF4-6681F201A2D7}"/>
                </c:ext>
              </c:extLst>
            </c:dLbl>
            <c:dLbl>
              <c:idx val="11"/>
              <c:layout>
                <c:manualLayout>
                  <c:x val="-7.2446530413167272E-3"/>
                  <c:y val="-4.254030244779249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FEMALE/70-79 y.o.</a:t>
                    </a:r>
                    <a:r>
                      <a:rPr lang="en-US" altLang="zh-CN" baseline="0"/>
                      <a:t> </a:t>
                    </a:r>
                    <a:fld id="{63B2F1AD-AF6E-47E3-BDBA-37F9B7170C82}" type="VALUE">
                      <a:rPr lang="en-US" altLang="zh-CN" baseline="0"/>
                      <a:pPr/>
                      <a:t>[値]</a:t>
                    </a:fld>
                    <a:endParaRPr lang="en-US" altLang="zh-CN" baseline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6805743924996395"/>
                      <c:h val="0.18948820728221388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7-1109-4F20-8FF4-6681F201A2D7}"/>
                </c:ext>
              </c:extLst>
            </c:dLbl>
            <c:numFmt formatCode="0.0&quot;%&quot;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>
                    <a:latin typeface="+mn-lt"/>
                  </a:defRPr>
                </a:pPr>
                <a:endParaRPr lang="ja-JP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eparator> </c:separator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%表'!$C$187:$C$198</c:f>
              <c:strCache>
                <c:ptCount val="12"/>
                <c:pt idx="0">
                  <c:v>男性/20-29才/全国</c:v>
                </c:pt>
                <c:pt idx="1">
                  <c:v>男性/30-39才/全国</c:v>
                </c:pt>
                <c:pt idx="2">
                  <c:v>男性/40-49才/全国</c:v>
                </c:pt>
                <c:pt idx="3">
                  <c:v>男性/50-59才/全国</c:v>
                </c:pt>
                <c:pt idx="4">
                  <c:v>男性/60-69才/全国</c:v>
                </c:pt>
                <c:pt idx="5">
                  <c:v>男性/70-79才/全国</c:v>
                </c:pt>
                <c:pt idx="6">
                  <c:v>女性/20-29才/全国</c:v>
                </c:pt>
                <c:pt idx="7">
                  <c:v>女性/30-39才/全国</c:v>
                </c:pt>
                <c:pt idx="8">
                  <c:v>女性/40-49才/全国</c:v>
                </c:pt>
                <c:pt idx="9">
                  <c:v>女性/50-59才/全国</c:v>
                </c:pt>
                <c:pt idx="10">
                  <c:v>女性/60-69才/全国</c:v>
                </c:pt>
                <c:pt idx="11">
                  <c:v>女性/70-79才/全国</c:v>
                </c:pt>
              </c:strCache>
            </c:strRef>
          </c:cat>
          <c:val>
            <c:numRef>
              <c:f>'%表'!$D$187:$D$198</c:f>
              <c:numCache>
                <c:formatCode>0.0</c:formatCode>
                <c:ptCount val="12"/>
                <c:pt idx="0">
                  <c:v>8.3333333333333304</c:v>
                </c:pt>
                <c:pt idx="1">
                  <c:v>8.3333333333333304</c:v>
                </c:pt>
                <c:pt idx="2">
                  <c:v>8.3333333333333304</c:v>
                </c:pt>
                <c:pt idx="3">
                  <c:v>8.3333333333333304</c:v>
                </c:pt>
                <c:pt idx="4">
                  <c:v>8.3333333333333304</c:v>
                </c:pt>
                <c:pt idx="5">
                  <c:v>8.3333333333333304</c:v>
                </c:pt>
                <c:pt idx="6">
                  <c:v>8.3333333333333304</c:v>
                </c:pt>
                <c:pt idx="7">
                  <c:v>8.3333333333333304</c:v>
                </c:pt>
                <c:pt idx="8">
                  <c:v>8.3333333333333304</c:v>
                </c:pt>
                <c:pt idx="9">
                  <c:v>8.3333333333333304</c:v>
                </c:pt>
                <c:pt idx="10">
                  <c:v>8.3333333333333304</c:v>
                </c:pt>
                <c:pt idx="11">
                  <c:v>8.3333333333333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1109-4F20-8FF4-6681F201A2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 w="12700">
      <a:noFill/>
    </a:ln>
  </c:spPr>
  <c:txPr>
    <a:bodyPr/>
    <a:lstStyle/>
    <a:p>
      <a:pPr>
        <a:defRPr sz="700" b="1">
          <a:latin typeface="ＭＳ ゴシック"/>
          <a:ea typeface="ＭＳ ゴシック"/>
          <a:cs typeface="ＭＳ ゴシック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4039651395837"/>
          <c:y val="0.18214326179423401"/>
          <c:w val="0.54440784118994967"/>
          <c:h val="0.72144467396129741"/>
        </c:manualLayout>
      </c:layout>
      <c:pieChart>
        <c:varyColors val="1"/>
        <c:ser>
          <c:idx val="0"/>
          <c:order val="0"/>
          <c:spPr>
            <a:ln w="12700">
              <a:solidFill>
                <a:srgbClr val="BFBFBF"/>
              </a:solidFill>
            </a:ln>
          </c:spPr>
          <c:dPt>
            <c:idx val="0"/>
            <c:bubble3D val="0"/>
            <c:spPr>
              <a:solidFill>
                <a:srgbClr val="95B3D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A52-4946-A56E-CBEDDB1A2DDD}"/>
              </c:ext>
            </c:extLst>
          </c:dPt>
          <c:dPt>
            <c:idx val="1"/>
            <c:bubble3D val="0"/>
            <c:spPr>
              <a:solidFill>
                <a:srgbClr val="DA969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A52-4946-A56E-CBEDDB1A2DDD}"/>
              </c:ext>
            </c:extLst>
          </c:dPt>
          <c:dLbls>
            <c:dLbl>
              <c:idx val="0"/>
              <c:layout>
                <c:manualLayout>
                  <c:x val="-0.13591486624218962"/>
                  <c:y val="9.580272431997533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Unmarried</a:t>
                    </a:r>
                  </a:p>
                  <a:p>
                    <a:fld id="{5133E93A-61F5-43BD-B4CB-BDF43957799E}" type="VALUE">
                      <a:rPr lang="en-US" altLang="ja-JP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4897626069375748"/>
                      <c:h val="0.2093091930906043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A52-4946-A56E-CBEDDB1A2DDD}"/>
                </c:ext>
              </c:extLst>
            </c:dLbl>
            <c:dLbl>
              <c:idx val="1"/>
              <c:layout>
                <c:manualLayout>
                  <c:x val="0.22262987295783826"/>
                  <c:y val="-0.13266882761062207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Married</a:t>
                    </a:r>
                  </a:p>
                  <a:p>
                    <a:fld id="{596103A0-1DA0-412D-99A3-DE9151EE01C3}" type="VALUE">
                      <a:rPr lang="en-US" altLang="ja-JP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4536116495120969"/>
                      <c:h val="0.22194435039995658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4A52-4946-A56E-CBEDDB1A2DDD}"/>
                </c:ext>
              </c:extLst>
            </c:dLbl>
            <c:numFmt formatCode="0.0&quot;%&quot;" sourceLinked="0"/>
            <c:spPr>
              <a:noFill/>
              <a:ln>
                <a:noFill/>
              </a:ln>
              <a:effectLst/>
            </c:spPr>
            <c:showLegendKey val="0"/>
            <c:showVal val="1"/>
            <c:showCatName val="1"/>
            <c:showSerName val="0"/>
            <c:showPercent val="0"/>
            <c:showBubbleSize val="0"/>
            <c:separator> </c:separator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%表'!$C$105:$C$106</c:f>
              <c:strCache>
                <c:ptCount val="2"/>
                <c:pt idx="0">
                  <c:v>未婚</c:v>
                </c:pt>
                <c:pt idx="1">
                  <c:v>既婚</c:v>
                </c:pt>
              </c:strCache>
            </c:strRef>
          </c:cat>
          <c:val>
            <c:numRef>
              <c:f>'%表'!$D$105:$D$106</c:f>
              <c:numCache>
                <c:formatCode>0.0</c:formatCode>
                <c:ptCount val="2"/>
                <c:pt idx="0">
                  <c:v>36.084142394822003</c:v>
                </c:pt>
                <c:pt idx="1">
                  <c:v>63.915857605177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A52-4946-A56E-CBEDDB1A2D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 w="12700">
      <a:noFill/>
    </a:ln>
  </c:spPr>
  <c:txPr>
    <a:bodyPr/>
    <a:lstStyle/>
    <a:p>
      <a:pPr>
        <a:defRPr sz="900" b="1">
          <a:latin typeface="+mn-lt"/>
          <a:ea typeface="ＭＳ ゴシック"/>
          <a:cs typeface="ＭＳ ゴシック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61093365899669"/>
          <c:y val="0.20640811476740592"/>
          <c:w val="0.54853424171886811"/>
          <c:h val="0.69911099986948122"/>
        </c:manualLayout>
      </c:layout>
      <c:pieChart>
        <c:varyColors val="1"/>
        <c:ser>
          <c:idx val="0"/>
          <c:order val="0"/>
          <c:spPr>
            <a:ln w="12700">
              <a:solidFill>
                <a:srgbClr val="BFBFBF"/>
              </a:solidFill>
            </a:ln>
          </c:spPr>
          <c:dPt>
            <c:idx val="0"/>
            <c:bubble3D val="0"/>
            <c:spPr>
              <a:solidFill>
                <a:srgbClr val="95B3D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132-42BD-A9D9-E4C5F12AF46B}"/>
              </c:ext>
            </c:extLst>
          </c:dPt>
          <c:dPt>
            <c:idx val="1"/>
            <c:bubble3D val="0"/>
            <c:spPr>
              <a:solidFill>
                <a:srgbClr val="DA969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132-42BD-A9D9-E4C5F12AF46B}"/>
              </c:ext>
            </c:extLst>
          </c:dPt>
          <c:dLbls>
            <c:dLbl>
              <c:idx val="0"/>
              <c:layout>
                <c:manualLayout>
                  <c:x val="-0.1891245142927811"/>
                  <c:y val="0.10386053111599938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No children</a:t>
                    </a:r>
                    <a:r>
                      <a:rPr lang="en-US" altLang="ja-JP" dirty="0"/>
                      <a:t> </a:t>
                    </a:r>
                    <a:fld id="{E172C184-22CC-41AF-8310-839781C94DDC}" type="VALUE">
                      <a:rPr lang="en-US" altLang="ja-JP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6130656712783962"/>
                      <c:h val="0.2384943249844356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132-42BD-A9D9-E4C5F12AF46B}"/>
                </c:ext>
              </c:extLst>
            </c:dLbl>
            <c:dLbl>
              <c:idx val="1"/>
              <c:layout>
                <c:manualLayout>
                  <c:x val="6.4443145091729034E-2"/>
                  <c:y val="-8.9157110523296348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With children</a:t>
                    </a:r>
                    <a:r>
                      <a:rPr lang="en-US" altLang="ja-JP" dirty="0"/>
                      <a:t> </a:t>
                    </a:r>
                  </a:p>
                  <a:p>
                    <a:fld id="{70B1F7FF-0D6A-46E2-92E2-D291268ADED5}" type="VALUE">
                      <a:rPr lang="en-US" altLang="ja-JP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44910311585120416"/>
                      <c:h val="0.2192268258850491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132-42BD-A9D9-E4C5F12AF46B}"/>
                </c:ext>
              </c:extLst>
            </c:dLbl>
            <c:numFmt formatCode="0.0&quot;%&quot;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b="1"/>
                </a:pPr>
                <a:endParaRPr lang="ja-JP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eparator> </c:separator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%表'!$C$113:$C$114</c:f>
              <c:strCache>
                <c:ptCount val="2"/>
                <c:pt idx="0">
                  <c:v>子供なし</c:v>
                </c:pt>
                <c:pt idx="1">
                  <c:v>子供あり</c:v>
                </c:pt>
              </c:strCache>
            </c:strRef>
          </c:cat>
          <c:val>
            <c:numRef>
              <c:f>'%表'!$D$113:$D$114</c:f>
              <c:numCache>
                <c:formatCode>0.0</c:formatCode>
                <c:ptCount val="2"/>
                <c:pt idx="0">
                  <c:v>40.5339805825243</c:v>
                </c:pt>
                <c:pt idx="1">
                  <c:v>59.4660194174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132-42BD-A9D9-E4C5F12AF4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 w="12700">
      <a:noFill/>
    </a:ln>
  </c:spPr>
  <c:txPr>
    <a:bodyPr/>
    <a:lstStyle/>
    <a:p>
      <a:pPr>
        <a:defRPr sz="900" b="0">
          <a:latin typeface="+mn-lt"/>
          <a:ea typeface="ＭＳ ゴシック"/>
          <a:cs typeface="ＭＳ ゴシック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468763670166225"/>
          <c:y val="0.28473934013730406"/>
          <c:w val="0.31062472659667539"/>
          <c:h val="0.5392960875981565"/>
        </c:manualLayout>
      </c:layout>
      <c:pieChart>
        <c:varyColors val="1"/>
        <c:ser>
          <c:idx val="0"/>
          <c:order val="0"/>
          <c:spPr>
            <a:ln w="12700">
              <a:solidFill>
                <a:srgbClr val="BFBFBF"/>
              </a:solidFill>
            </a:ln>
          </c:spPr>
          <c:dPt>
            <c:idx val="0"/>
            <c:bubble3D val="0"/>
            <c:spPr>
              <a:solidFill>
                <a:srgbClr val="95B3D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3B9-480B-9197-9D0BB99BE6E1}"/>
              </c:ext>
            </c:extLst>
          </c:dPt>
          <c:dPt>
            <c:idx val="1"/>
            <c:bubble3D val="0"/>
            <c:spPr>
              <a:solidFill>
                <a:srgbClr val="DA969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03B9-480B-9197-9D0BB99BE6E1}"/>
              </c:ext>
            </c:extLst>
          </c:dPt>
          <c:dPt>
            <c:idx val="2"/>
            <c:bubble3D val="0"/>
            <c:spPr>
              <a:solidFill>
                <a:srgbClr val="C4D79B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03B9-480B-9197-9D0BB99BE6E1}"/>
              </c:ext>
            </c:extLst>
          </c:dPt>
          <c:dPt>
            <c:idx val="3"/>
            <c:bubble3D val="0"/>
            <c:spPr>
              <a:solidFill>
                <a:srgbClr val="FABF8F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03B9-480B-9197-9D0BB99BE6E1}"/>
              </c:ext>
            </c:extLst>
          </c:dPt>
          <c:dPt>
            <c:idx val="4"/>
            <c:bubble3D val="0"/>
            <c:spPr>
              <a:solidFill>
                <a:srgbClr val="92CDD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03B9-480B-9197-9D0BB99BE6E1}"/>
              </c:ext>
            </c:extLst>
          </c:dPt>
          <c:dPt>
            <c:idx val="5"/>
            <c:bubble3D val="0"/>
            <c:spPr>
              <a:solidFill>
                <a:srgbClr val="B1A0C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03B9-480B-9197-9D0BB99BE6E1}"/>
              </c:ext>
            </c:extLst>
          </c:dPt>
          <c:dPt>
            <c:idx val="6"/>
            <c:bubble3D val="0"/>
            <c:spPr>
              <a:solidFill>
                <a:srgbClr val="538DD5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03B9-480B-9197-9D0BB99BE6E1}"/>
              </c:ext>
            </c:extLst>
          </c:dPt>
          <c:dPt>
            <c:idx val="7"/>
            <c:bubble3D val="0"/>
            <c:spPr>
              <a:solidFill>
                <a:srgbClr val="B8CCE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03B9-480B-9197-9D0BB99BE6E1}"/>
              </c:ext>
            </c:extLst>
          </c:dPt>
          <c:dPt>
            <c:idx val="8"/>
            <c:bubble3D val="0"/>
            <c:spPr>
              <a:solidFill>
                <a:srgbClr val="E6B8B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03B9-480B-9197-9D0BB99BE6E1}"/>
              </c:ext>
            </c:extLst>
          </c:dPt>
          <c:dPt>
            <c:idx val="9"/>
            <c:bubble3D val="0"/>
            <c:spPr>
              <a:solidFill>
                <a:srgbClr val="D8E4B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03B9-480B-9197-9D0BB99BE6E1}"/>
              </c:ext>
            </c:extLst>
          </c:dPt>
          <c:dPt>
            <c:idx val="10"/>
            <c:bubble3D val="0"/>
            <c:spPr>
              <a:solidFill>
                <a:srgbClr val="FCD5B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03B9-480B-9197-9D0BB99BE6E1}"/>
              </c:ext>
            </c:extLst>
          </c:dPt>
          <c:dPt>
            <c:idx val="11"/>
            <c:bubble3D val="0"/>
            <c:spPr>
              <a:solidFill>
                <a:srgbClr val="B7DEE8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7-03B9-480B-9197-9D0BB99BE6E1}"/>
              </c:ext>
            </c:extLst>
          </c:dPt>
          <c:dLbls>
            <c:dLbl>
              <c:idx val="0"/>
              <c:layout>
                <c:manualLayout>
                  <c:x val="-1.6221973163091707E-2"/>
                  <c:y val="-0.10648270425493633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dirty="0"/>
                      <a:t>public servant</a:t>
                    </a:r>
                    <a:r>
                      <a:rPr lang="en-US" altLang="ja-JP" baseline="0" dirty="0"/>
                      <a:t> </a:t>
                    </a:r>
                    <a:fld id="{4259768D-12DD-4829-8A71-C7F16EDBDD21}" type="VALUE">
                      <a:rPr lang="en-US" altLang="ja-JP" baseline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5692422181245959"/>
                      <c:h val="8.5839362879592235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03B9-480B-9197-9D0BB99BE6E1}"/>
                </c:ext>
              </c:extLst>
            </c:dLbl>
            <c:dLbl>
              <c:idx val="1"/>
              <c:layout>
                <c:manualLayout>
                  <c:x val="0.13394517509018988"/>
                  <c:y val="4.1990933573187839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baseline="0" dirty="0"/>
                      <a:t>manager/officer </a:t>
                    </a:r>
                    <a:fld id="{00E95A84-45C9-46BE-800E-FE9297DA13B8}" type="VALUE">
                      <a:rPr lang="en-US" altLang="ja-JP" baseline="0" smtClean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2834110210189771"/>
                      <c:h val="0.1734579540281019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03B9-480B-9197-9D0BB99BE6E1}"/>
                </c:ext>
              </c:extLst>
            </c:dLbl>
            <c:dLbl>
              <c:idx val="2"/>
              <c:layout>
                <c:manualLayout>
                  <c:x val="0.25969165609665085"/>
                  <c:y val="8.058282903667732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TW" dirty="0"/>
                      <a:t>office worker </a:t>
                    </a:r>
                    <a:fld id="{F4D9507C-82D0-454C-B8D2-918BAC1B1771}" type="VALUE">
                      <a:rPr lang="en-US" altLang="ja-JP" baseline="0" smtClean="0"/>
                      <a:pPr/>
                      <a:t>[値]</a:t>
                    </a:fld>
                    <a:endParaRPr lang="en-US" altLang="zh-TW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03B9-480B-9197-9D0BB99BE6E1}"/>
                </c:ext>
              </c:extLst>
            </c:dLbl>
            <c:dLbl>
              <c:idx val="3"/>
              <c:layout>
                <c:manualLayout>
                  <c:x val="2.045043868404843E-2"/>
                  <c:y val="9.2724104149081131E-3"/>
                </c:manualLayout>
              </c:layout>
              <c:tx>
                <c:rich>
                  <a:bodyPr/>
                  <a:lstStyle/>
                  <a:p>
                    <a:r>
                      <a:rPr lang="en-US" altLang="zh-TW" dirty="0"/>
                      <a:t>engineering company employee </a:t>
                    </a:r>
                    <a:r>
                      <a:rPr lang="en-US" altLang="ja-JP" baseline="0" dirty="0"/>
                      <a:t> </a:t>
                    </a:r>
                    <a:fld id="{5D374D4B-3535-4351-A117-20150E99CB24}" type="VALUE">
                      <a:rPr lang="en-US" altLang="ja-JP" baseline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2622804932333488"/>
                      <c:h val="0.12650026089686153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03B9-480B-9197-9D0BB99BE6E1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 altLang="ja-JP" dirty="0"/>
                      <a:t>Company employee (other) </a:t>
                    </a:r>
                    <a:fld id="{1EF85830-F395-46C3-B331-5A1D2587D6D6}" type="VALUE">
                      <a:rPr lang="en-US" altLang="ja-JP" baseline="0" smtClean="0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03B9-480B-9197-9D0BB99BE6E1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 altLang="ja-JP" dirty="0"/>
                      <a:t>Self-employed</a:t>
                    </a:r>
                  </a:p>
                  <a:p>
                    <a:fld id="{2702FC11-24C7-44FE-814E-1F25C5BAF294}" type="VALUE">
                      <a:rPr lang="en-US" altLang="ja-JP" baseline="0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03B9-480B-9197-9D0BB99BE6E1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 sz="700" dirty="0">
                        <a:latin typeface="+mn-ea"/>
                        <a:ea typeface="+mn-ea"/>
                      </a:rPr>
                      <a:t>freelance </a:t>
                    </a:r>
                    <a:fld id="{12043055-6A3E-491E-99B0-07257136DDBD}" type="VALUE">
                      <a:rPr lang="en-US" altLang="ja-JP" sz="700" smtClean="0">
                        <a:latin typeface="+mn-ea"/>
                        <a:ea typeface="+mn-ea"/>
                      </a:rPr>
                      <a:pPr/>
                      <a:t>[値]</a:t>
                    </a:fld>
                    <a:endParaRPr lang="en-US" sz="700" dirty="0">
                      <a:latin typeface="+mn-ea"/>
                      <a:ea typeface="+mn-ea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03B9-480B-9197-9D0BB99BE6E1}"/>
                </c:ext>
              </c:extLst>
            </c:dLbl>
            <c:dLbl>
              <c:idx val="7"/>
              <c:layout>
                <c:manualLayout>
                  <c:x val="1.1315395731364482E-2"/>
                  <c:y val="-2.5266500209404835E-2"/>
                </c:manualLayout>
              </c:layout>
              <c:tx>
                <c:rich>
                  <a:bodyPr/>
                  <a:lstStyle/>
                  <a:p>
                    <a:r>
                      <a:rPr lang="en-US" altLang="zh-TW" dirty="0"/>
                      <a:t>Housewife (househusband)</a:t>
                    </a:r>
                    <a:r>
                      <a:rPr lang="en-US" altLang="zh-TW" baseline="0" dirty="0"/>
                      <a:t> </a:t>
                    </a:r>
                    <a:fld id="{1FE50B59-AB7D-4D1B-8734-3E2EFDB29D76}" type="VALUE">
                      <a:rPr lang="en-US" altLang="zh-TW" baseline="0" smtClean="0"/>
                      <a:pPr/>
                      <a:t>[値]</a:t>
                    </a:fld>
                    <a:endParaRPr lang="en-US" altLang="zh-TW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4002971602979865"/>
                      <c:h val="0.13365777399887327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03B9-480B-9197-9D0BB99BE6E1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ja-JP" dirty="0"/>
                      <a:t>Part-time job</a:t>
                    </a:r>
                    <a:r>
                      <a:rPr lang="en-US" altLang="ja-JP" baseline="0" dirty="0"/>
                      <a:t> </a:t>
                    </a:r>
                    <a:fld id="{2BF63FCC-BD8B-4D63-805E-18E52D255A9C}" type="VALUE">
                      <a:rPr lang="en-US" altLang="ja-JP" baseline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03B9-480B-9197-9D0BB99BE6E1}"/>
                </c:ext>
              </c:extLst>
            </c:dLbl>
            <c:dLbl>
              <c:idx val="9"/>
              <c:layout>
                <c:manualLayout>
                  <c:x val="5.1681404963418803E-2"/>
                  <c:y val="4.6236686666877955E-2"/>
                </c:manualLayout>
              </c:layout>
              <c:tx>
                <c:rich>
                  <a:bodyPr/>
                  <a:lstStyle/>
                  <a:p>
                    <a:r>
                      <a:rPr lang="en-US" sz="700" dirty="0">
                        <a:latin typeface="+mn-ea"/>
                        <a:ea typeface="+mn-ea"/>
                      </a:rPr>
                      <a:t>Student</a:t>
                    </a:r>
                  </a:p>
                  <a:p>
                    <a:fld id="{8F2DC82B-5E97-496B-9A53-B4EC68EBDA24}" type="VALUE">
                      <a:rPr lang="en-US" altLang="ja-JP" sz="700" smtClean="0">
                        <a:latin typeface="+mn-ea"/>
                        <a:ea typeface="+mn-ea"/>
                      </a:rPr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0473720843952351"/>
                      <c:h val="0.13332432494236363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03B9-480B-9197-9D0BB99BE6E1}"/>
                </c:ext>
              </c:extLst>
            </c:dLbl>
            <c:dLbl>
              <c:idx val="10"/>
              <c:layout>
                <c:manualLayout>
                  <c:x val="-0.1933758699993193"/>
                  <c:y val="1.9276432178249724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dirty="0"/>
                      <a:t>Others</a:t>
                    </a:r>
                  </a:p>
                  <a:p>
                    <a:r>
                      <a:rPr lang="en-US" altLang="ja-JP" baseline="0" dirty="0"/>
                      <a:t> </a:t>
                    </a:r>
                    <a:fld id="{C5552913-EF01-42E6-896D-3665F5384241}" type="VALUE">
                      <a:rPr lang="en-US" altLang="ja-JP" baseline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03B9-480B-9197-9D0BB99BE6E1}"/>
                </c:ext>
              </c:extLst>
            </c:dLbl>
            <c:dLbl>
              <c:idx val="11"/>
              <c:layout>
                <c:manualLayout>
                  <c:x val="5.7708817241679991E-2"/>
                  <c:y val="7.860531376839841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dirty="0"/>
                      <a:t>Unemployed </a:t>
                    </a:r>
                    <a:fld id="{784CE8B6-D3EF-488A-B815-CF16A4BC1097}" type="VALUE">
                      <a:rPr lang="en-US" altLang="ja-JP" baseline="0" smtClean="0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4611130930509462"/>
                      <c:h val="0.1531287874220687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7-03B9-480B-9197-9D0BB99BE6E1}"/>
                </c:ext>
              </c:extLst>
            </c:dLbl>
            <c:numFmt formatCode="0.0&quot;%&quot;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700">
                    <a:latin typeface="+mn-lt"/>
                    <a:ea typeface="+mn-ea"/>
                  </a:defRPr>
                </a:pPr>
                <a:endParaRPr lang="ja-JP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eparator> </c:separator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%表'!$C$155:$C$166</c:f>
              <c:strCache>
                <c:ptCount val="12"/>
                <c:pt idx="0">
                  <c:v>公務員</c:v>
                </c:pt>
                <c:pt idx="1">
                  <c:v>経営者・役員</c:v>
                </c:pt>
                <c:pt idx="2">
                  <c:v>会社員(事務系)</c:v>
                </c:pt>
                <c:pt idx="3">
                  <c:v>会社員(技術系)</c:v>
                </c:pt>
                <c:pt idx="4">
                  <c:v>会社員(その他)</c:v>
                </c:pt>
                <c:pt idx="5">
                  <c:v>自営業</c:v>
                </c:pt>
                <c:pt idx="6">
                  <c:v>自由業</c:v>
                </c:pt>
                <c:pt idx="7">
                  <c:v>専業主婦(主夫)</c:v>
                </c:pt>
                <c:pt idx="8">
                  <c:v>パート・アルバイト</c:v>
                </c:pt>
                <c:pt idx="9">
                  <c:v>学生</c:v>
                </c:pt>
                <c:pt idx="10">
                  <c:v>その他</c:v>
                </c:pt>
                <c:pt idx="11">
                  <c:v>無職</c:v>
                </c:pt>
              </c:strCache>
            </c:strRef>
          </c:cat>
          <c:val>
            <c:numRef>
              <c:f>'%表'!$D$155:$D$166</c:f>
              <c:numCache>
                <c:formatCode>0.0</c:formatCode>
                <c:ptCount val="12"/>
                <c:pt idx="0">
                  <c:v>3.15533980582524</c:v>
                </c:pt>
                <c:pt idx="1">
                  <c:v>1.6990291262135899</c:v>
                </c:pt>
                <c:pt idx="2">
                  <c:v>14.482200647249201</c:v>
                </c:pt>
                <c:pt idx="3">
                  <c:v>10.760517799352799</c:v>
                </c:pt>
                <c:pt idx="4">
                  <c:v>12.540453074433699</c:v>
                </c:pt>
                <c:pt idx="5">
                  <c:v>4.2880258899676402</c:v>
                </c:pt>
                <c:pt idx="6">
                  <c:v>2.02265372168285</c:v>
                </c:pt>
                <c:pt idx="7">
                  <c:v>20.145631067961201</c:v>
                </c:pt>
                <c:pt idx="8">
                  <c:v>11.6504854368932</c:v>
                </c:pt>
                <c:pt idx="9">
                  <c:v>2.2653721682847898</c:v>
                </c:pt>
                <c:pt idx="10">
                  <c:v>2.9126213592233001</c:v>
                </c:pt>
                <c:pt idx="11">
                  <c:v>14.07766990291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03B9-480B-9197-9D0BB99BE6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 w="12700">
      <a:noFill/>
    </a:ln>
  </c:spPr>
  <c:txPr>
    <a:bodyPr/>
    <a:lstStyle/>
    <a:p>
      <a:pPr>
        <a:defRPr sz="800" b="1">
          <a:latin typeface="ＭＳ ゴシック"/>
          <a:ea typeface="ＭＳ ゴシック"/>
          <a:cs typeface="ＭＳ ゴシック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468763670166225"/>
          <c:y val="0.28473934013730406"/>
          <c:w val="0.31062472659667539"/>
          <c:h val="0.5392960875981565"/>
        </c:manualLayout>
      </c:layout>
      <c:pieChart>
        <c:varyColors val="1"/>
        <c:ser>
          <c:idx val="0"/>
          <c:order val="0"/>
          <c:spPr>
            <a:ln w="12700">
              <a:solidFill>
                <a:srgbClr val="BFBFBF"/>
              </a:solidFill>
            </a:ln>
          </c:spPr>
          <c:dPt>
            <c:idx val="0"/>
            <c:bubble3D val="0"/>
            <c:spPr>
              <a:solidFill>
                <a:srgbClr val="95B3D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F4F-4D6F-8C77-CCBB396926E6}"/>
              </c:ext>
            </c:extLst>
          </c:dPt>
          <c:dPt>
            <c:idx val="1"/>
            <c:bubble3D val="0"/>
            <c:spPr>
              <a:solidFill>
                <a:srgbClr val="DA969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F4F-4D6F-8C77-CCBB396926E6}"/>
              </c:ext>
            </c:extLst>
          </c:dPt>
          <c:dPt>
            <c:idx val="2"/>
            <c:bubble3D val="0"/>
            <c:spPr>
              <a:solidFill>
                <a:srgbClr val="C4D79B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F4F-4D6F-8C77-CCBB396926E6}"/>
              </c:ext>
            </c:extLst>
          </c:dPt>
          <c:dPt>
            <c:idx val="3"/>
            <c:bubble3D val="0"/>
            <c:spPr>
              <a:solidFill>
                <a:srgbClr val="FABF8F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F4F-4D6F-8C77-CCBB396926E6}"/>
              </c:ext>
            </c:extLst>
          </c:dPt>
          <c:dPt>
            <c:idx val="4"/>
            <c:bubble3D val="0"/>
            <c:spPr>
              <a:solidFill>
                <a:srgbClr val="92CDD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F4F-4D6F-8C77-CCBB396926E6}"/>
              </c:ext>
            </c:extLst>
          </c:dPt>
          <c:dPt>
            <c:idx val="5"/>
            <c:bubble3D val="0"/>
            <c:spPr>
              <a:solidFill>
                <a:srgbClr val="B1A0C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F4F-4D6F-8C77-CCBB396926E6}"/>
              </c:ext>
            </c:extLst>
          </c:dPt>
          <c:dPt>
            <c:idx val="6"/>
            <c:bubble3D val="0"/>
            <c:spPr>
              <a:solidFill>
                <a:srgbClr val="538DD5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F4F-4D6F-8C77-CCBB396926E6}"/>
              </c:ext>
            </c:extLst>
          </c:dPt>
          <c:dPt>
            <c:idx val="7"/>
            <c:bubble3D val="0"/>
            <c:spPr>
              <a:solidFill>
                <a:srgbClr val="B8CCE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F4F-4D6F-8C77-CCBB396926E6}"/>
              </c:ext>
            </c:extLst>
          </c:dPt>
          <c:dPt>
            <c:idx val="8"/>
            <c:bubble3D val="0"/>
            <c:spPr>
              <a:solidFill>
                <a:srgbClr val="E6B8B7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1-6F4F-4D6F-8C77-CCBB396926E6}"/>
              </c:ext>
            </c:extLst>
          </c:dPt>
          <c:dPt>
            <c:idx val="9"/>
            <c:bubble3D val="0"/>
            <c:spPr>
              <a:solidFill>
                <a:srgbClr val="D8E4BC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3-6F4F-4D6F-8C77-CCBB396926E6}"/>
              </c:ext>
            </c:extLst>
          </c:dPt>
          <c:dPt>
            <c:idx val="10"/>
            <c:bubble3D val="0"/>
            <c:spPr>
              <a:solidFill>
                <a:srgbClr val="FCD5B4"/>
              </a:solidFill>
              <a:ln w="12700">
                <a:solidFill>
                  <a:srgbClr val="BFBFBF"/>
                </a:solidFill>
              </a:ln>
            </c:spPr>
            <c:extLst>
              <c:ext xmlns:c16="http://schemas.microsoft.com/office/drawing/2014/chart" uri="{C3380CC4-5D6E-409C-BE32-E72D297353CC}">
                <c16:uniqueId val="{00000015-6F4F-4D6F-8C77-CCBB396926E6}"/>
              </c:ext>
            </c:extLst>
          </c:dPt>
          <c:dLbls>
            <c:dLbl>
              <c:idx val="0"/>
              <c:layout>
                <c:manualLayout>
                  <c:x val="-7.796616226554845E-2"/>
                  <c:y val="-7.002245814836798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dirty="0"/>
                      <a:t> &lt;2 million yen </a:t>
                    </a:r>
                    <a:fld id="{606DB5B3-C9B1-4DE0-B901-F34B6086D71A}" type="VALUE">
                      <a:rPr lang="en-US" altLang="ja-JP" baseline="0" smtClean="0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5953614776771847"/>
                      <c:h val="8.4314947962261175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6F4F-4D6F-8C77-CCBB396926E6}"/>
                </c:ext>
              </c:extLst>
            </c:dLbl>
            <c:dLbl>
              <c:idx val="1"/>
              <c:layout>
                <c:manualLayout>
                  <c:x val="-0.12543964063592689"/>
                  <c:y val="7.9244110044570132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</a:rPr>
                      <a:t>2-4 million yen</a:t>
                    </a:r>
                    <a:endParaRPr lang="en-US" altLang="ja-JP" sz="700" b="1" baseline="0" dirty="0">
                      <a:latin typeface="+mn-lt"/>
                    </a:endParaRPr>
                  </a:p>
                  <a:p>
                    <a:fld id="{9A9E6885-3DF7-4811-893C-52505DEE1C74}" type="VALUE">
                      <a:rPr lang="en-US" altLang="ja-JP" sz="700" b="1" baseline="0" smtClean="0">
                        <a:latin typeface="+mn-lt"/>
                      </a:rPr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9656673794646915"/>
                      <c:h val="0.15715891153818654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6F4F-4D6F-8C77-CCBB396926E6}"/>
                </c:ext>
              </c:extLst>
            </c:dLbl>
            <c:dLbl>
              <c:idx val="2"/>
              <c:layout>
                <c:manualLayout>
                  <c:x val="-9.9913497668182111E-2"/>
                  <c:y val="-0.10518982006715684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</a:rPr>
                      <a:t>4-6 million yen</a:t>
                    </a:r>
                    <a:r>
                      <a:rPr lang="en-US" altLang="ja-JP" sz="700" b="1" baseline="0" dirty="0">
                        <a:latin typeface="+mn-lt"/>
                      </a:rPr>
                      <a:t> </a:t>
                    </a:r>
                    <a:fld id="{FF769698-7FE0-4DB5-B2E2-44AF4D812976}" type="VALUE">
                      <a:rPr lang="en-US" altLang="ja-JP" sz="700" b="1" baseline="0" smtClean="0">
                        <a:latin typeface="+mn-lt"/>
                      </a:rPr>
                      <a:pPr/>
                      <a:t>[値]</a:t>
                    </a:fld>
                    <a:endParaRPr lang="en-US" altLang="ja-JP" sz="700" b="1" baseline="0" dirty="0">
                      <a:latin typeface="+mn-lt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42279296782941589"/>
                      <c:h val="0.12650000764822256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6F4F-4D6F-8C77-CCBB396926E6}"/>
                </c:ext>
              </c:extLst>
            </c:dLbl>
            <c:dLbl>
              <c:idx val="3"/>
              <c:layout>
                <c:manualLayout>
                  <c:x val="0.27861296811830794"/>
                  <c:y val="0.11631201016665708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</a:rPr>
                      <a:t>6-8 million yen </a:t>
                    </a:r>
                    <a:fld id="{3BB6669E-7C30-4B6C-84A3-540CC8CCD695}" type="VALUE">
                      <a:rPr lang="en-US" altLang="ja-JP" sz="700" b="1" baseline="0" smtClean="0">
                        <a:latin typeface="+mn-lt"/>
                      </a:rPr>
                      <a:pPr/>
                      <a:t>[値]</a:t>
                    </a:fld>
                    <a:endParaRPr lang="en-US" altLang="ja-JP" sz="700" b="1" i="0" u="none" strike="noStrike" baseline="0" dirty="0">
                      <a:effectLst/>
                      <a:latin typeface="+mn-lt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37074957411633458"/>
                      <c:h val="0.1287776564799056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6F4F-4D6F-8C77-CCBB396926E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</a:rPr>
                      <a:t>8-10 million yen </a:t>
                    </a:r>
                    <a:r>
                      <a:rPr lang="en-US" altLang="ja-JP" sz="700" b="1" baseline="0" dirty="0">
                        <a:latin typeface="+mn-lt"/>
                      </a:rPr>
                      <a:t> </a:t>
                    </a:r>
                    <a:fld id="{440D99AD-C587-43EE-A044-CC1D7D25FB9D}" type="VALUE">
                      <a:rPr lang="en-US" altLang="ja-JP" sz="700" b="1" baseline="0">
                        <a:latin typeface="+mn-lt"/>
                      </a:rPr>
                      <a:pPr/>
                      <a:t>[値]</a:t>
                    </a:fld>
                    <a:endParaRPr lang="en-US" altLang="ja-JP" sz="700" b="1" baseline="0" dirty="0">
                      <a:latin typeface="+mn-lt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6F4F-4D6F-8C77-CCBB396926E6}"/>
                </c:ext>
              </c:extLst>
            </c:dLbl>
            <c:dLbl>
              <c:idx val="5"/>
              <c:layout>
                <c:manualLayout>
                  <c:x val="-0.17362156125272996"/>
                  <c:y val="2.9563244876358773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</a:rPr>
                      <a:t>10-12 million yen </a:t>
                    </a:r>
                    <a:r>
                      <a:rPr lang="en-US" altLang="ja-JP" sz="700" b="1" baseline="0" dirty="0">
                        <a:latin typeface="+mn-lt"/>
                      </a:rPr>
                      <a:t> </a:t>
                    </a:r>
                    <a:fld id="{F8F8AE63-61DE-4883-BCCE-CCB664CD9BC4}" type="VALUE">
                      <a:rPr lang="en-US" altLang="ja-JP" sz="700" b="1" baseline="0">
                        <a:latin typeface="+mn-lt"/>
                      </a:rPr>
                      <a:pPr/>
                      <a:t>[値]</a:t>
                    </a:fld>
                    <a:endParaRPr lang="en-US" altLang="ja-JP" sz="700" b="1" baseline="0" dirty="0">
                      <a:latin typeface="+mn-lt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6F4F-4D6F-8C77-CCBB396926E6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 altLang="ja-JP" sz="700" b="1" i="0" u="none" strike="noStrike" baseline="0" dirty="0">
                        <a:effectLst/>
                        <a:latin typeface="+mn-lt"/>
                        <a:ea typeface="+mn-ea"/>
                      </a:rPr>
                      <a:t>12-14 million yen</a:t>
                    </a:r>
                  </a:p>
                  <a:p>
                    <a:fld id="{9033C934-52AD-4305-B554-BD5EB3CC27B6}" type="VALUE">
                      <a:rPr lang="en-US" altLang="ja-JP" sz="700" b="1" baseline="0" smtClean="0">
                        <a:latin typeface="+mn-lt"/>
                        <a:ea typeface="+mn-ea"/>
                      </a:rPr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6F4F-4D6F-8C77-CCBB396926E6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 altLang="ja-JP" dirty="0"/>
                      <a:t> 15-20 million yen</a:t>
                    </a:r>
                    <a:r>
                      <a:rPr lang="en-US" altLang="ja-JP" baseline="0" dirty="0"/>
                      <a:t> </a:t>
                    </a:r>
                    <a:fld id="{2F3A2D22-6FA1-4D79-8D40-AA3168383111}" type="VALUE">
                      <a:rPr lang="en-US" altLang="ja-JP" baseline="0"/>
                      <a:pPr/>
                      <a:t>[値]</a:t>
                    </a:fld>
                    <a:endParaRPr lang="en-US" altLang="ja-JP" baseline="0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layout>
                    <c:manualLayout>
                      <c:w val="0.2074991206575352"/>
                      <c:h val="9.1779346997128225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6F4F-4D6F-8C77-CCBB396926E6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ja-JP" dirty="0"/>
                      <a:t> &gt;20 million yen </a:t>
                    </a:r>
                    <a:fld id="{E959B90F-4F62-4D83-8F2A-ED24941CC3F9}" type="VALUE">
                      <a:rPr lang="en-US" altLang="ja-JP" baseline="0" smtClean="0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6F4F-4D6F-8C77-CCBB396926E6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 altLang="ja-JP" dirty="0"/>
                      <a:t>Unknown</a:t>
                    </a:r>
                  </a:p>
                  <a:p>
                    <a:fld id="{CE7C849A-4E4E-401E-98F1-F3A1715253C0}" type="VALUE">
                      <a:rPr lang="en-US" altLang="ja-JP" baseline="0" smtClean="0"/>
                      <a:pPr/>
                      <a:t>[値]</a:t>
                    </a:fld>
                    <a:endParaRPr lang="ja-JP" altLang="en-US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6F4F-4D6F-8C77-CCBB396926E6}"/>
                </c:ext>
              </c:extLst>
            </c:dLbl>
            <c:dLbl>
              <c:idx val="10"/>
              <c:layout>
                <c:manualLayout>
                  <c:x val="6.4701801755799579E-2"/>
                  <c:y val="2.5882409018327415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 dirty="0"/>
                      <a:t>No answer </a:t>
                    </a:r>
                    <a:fld id="{79E88AF5-C00D-4485-BEBC-2D5E06C1A015}" type="VALUE">
                      <a:rPr lang="en-US" altLang="ja-JP" baseline="0" smtClean="0"/>
                      <a:pPr/>
                      <a:t>[値]</a:t>
                    </a:fld>
                    <a:endParaRPr lang="en-US" altLang="ja-JP" dirty="0"/>
                  </a:p>
                </c:rich>
              </c:tx>
              <c:showLegendKey val="0"/>
              <c:showVal val="1"/>
              <c:showCatName val="1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6F4F-4D6F-8C77-CCBB396926E6}"/>
                </c:ext>
              </c:extLst>
            </c:dLbl>
            <c:numFmt formatCode="0.0&quot;%&quot;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700">
                    <a:latin typeface="+mn-lt"/>
                    <a:ea typeface="+mn-ea"/>
                  </a:defRPr>
                </a:pPr>
                <a:endParaRPr lang="ja-JP"/>
              </a:p>
            </c:txPr>
            <c:showLegendKey val="0"/>
            <c:showVal val="1"/>
            <c:showCatName val="1"/>
            <c:showSerName val="0"/>
            <c:showPercent val="0"/>
            <c:showBubbleSize val="0"/>
            <c:separator> </c:separator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%表'!$C$121:$C$131</c:f>
              <c:strCache>
                <c:ptCount val="11"/>
                <c:pt idx="0">
                  <c:v>200万未満</c:v>
                </c:pt>
                <c:pt idx="1">
                  <c:v>200～400万未満</c:v>
                </c:pt>
                <c:pt idx="2">
                  <c:v>400～600万未満</c:v>
                </c:pt>
                <c:pt idx="3">
                  <c:v>600～800万未満</c:v>
                </c:pt>
                <c:pt idx="4">
                  <c:v>800～1000万未満</c:v>
                </c:pt>
                <c:pt idx="5">
                  <c:v>1000～1200万未満</c:v>
                </c:pt>
                <c:pt idx="6">
                  <c:v>1200～1500万未満</c:v>
                </c:pt>
                <c:pt idx="7">
                  <c:v>1500～2000万未満</c:v>
                </c:pt>
                <c:pt idx="8">
                  <c:v>2000万円以上</c:v>
                </c:pt>
                <c:pt idx="9">
                  <c:v>わからない</c:v>
                </c:pt>
                <c:pt idx="10">
                  <c:v>無回答</c:v>
                </c:pt>
              </c:strCache>
            </c:strRef>
          </c:cat>
          <c:val>
            <c:numRef>
              <c:f>'%表'!$D$121:$D$131</c:f>
              <c:numCache>
                <c:formatCode>0.0</c:formatCode>
                <c:ptCount val="11"/>
                <c:pt idx="0">
                  <c:v>7.4433656957928802</c:v>
                </c:pt>
                <c:pt idx="1">
                  <c:v>22.006472491909399</c:v>
                </c:pt>
                <c:pt idx="2">
                  <c:v>19.498381877022702</c:v>
                </c:pt>
                <c:pt idx="3">
                  <c:v>12.7831715210356</c:v>
                </c:pt>
                <c:pt idx="4">
                  <c:v>6.7152103559870504</c:v>
                </c:pt>
                <c:pt idx="5">
                  <c:v>3.8834951456310698</c:v>
                </c:pt>
                <c:pt idx="6">
                  <c:v>3.2362459546925599</c:v>
                </c:pt>
                <c:pt idx="7">
                  <c:v>1.53721682847896</c:v>
                </c:pt>
                <c:pt idx="8">
                  <c:v>0.64724919093851097</c:v>
                </c:pt>
                <c:pt idx="9">
                  <c:v>11.1650485436893</c:v>
                </c:pt>
                <c:pt idx="10">
                  <c:v>11.084142394822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6F4F-4D6F-8C77-CCBB396926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 w="12700">
      <a:noFill/>
    </a:ln>
  </c:spPr>
  <c:txPr>
    <a:bodyPr/>
    <a:lstStyle/>
    <a:p>
      <a:pPr>
        <a:defRPr sz="800" b="1">
          <a:latin typeface="ＭＳ ゴシック"/>
          <a:ea typeface="ＭＳ ゴシック"/>
          <a:cs typeface="ＭＳ ゴシック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475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874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150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027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29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155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330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314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795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02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419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0CFCE-EE32-467A-9EA4-4DFD1C9E4F76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FBE33-4208-48FF-9A48-19BF126B6E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856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CD814940-B1EA-4597-BB9A-211C1214E4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7708506"/>
              </p:ext>
            </p:extLst>
          </p:nvPr>
        </p:nvGraphicFramePr>
        <p:xfrm>
          <a:off x="579698" y="1050895"/>
          <a:ext cx="2629474" cy="1922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6349315-EF18-4661-AB51-E06DC7AB26CC}"/>
              </a:ext>
            </a:extLst>
          </p:cNvPr>
          <p:cNvSpPr txBox="1"/>
          <p:nvPr/>
        </p:nvSpPr>
        <p:spPr>
          <a:xfrm>
            <a:off x="894310" y="820063"/>
            <a:ext cx="2000250" cy="438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Age and Sex </a:t>
            </a:r>
          </a:p>
          <a:p>
            <a:pPr algn="ctr"/>
            <a:r>
              <a:rPr lang="en-US" altLang="ja-JP" sz="1050" b="1" dirty="0"/>
              <a:t>(n=1236)</a:t>
            </a:r>
            <a:endParaRPr lang="ja-JP" altLang="en-US" sz="1200" b="1" dirty="0"/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71493CCD-F90D-499C-A07A-467B58CB00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7069307"/>
              </p:ext>
            </p:extLst>
          </p:nvPr>
        </p:nvGraphicFramePr>
        <p:xfrm>
          <a:off x="3685763" y="1075140"/>
          <a:ext cx="1915136" cy="1733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87C0D1D-8D4B-4E88-ACFF-7D4DCDB25B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1139368"/>
              </p:ext>
            </p:extLst>
          </p:nvPr>
        </p:nvGraphicFramePr>
        <p:xfrm>
          <a:off x="6557342" y="931520"/>
          <a:ext cx="1965081" cy="2006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4B80B614-E59A-43B9-9BD2-A2E4791E15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4951009"/>
              </p:ext>
            </p:extLst>
          </p:nvPr>
        </p:nvGraphicFramePr>
        <p:xfrm>
          <a:off x="793558" y="3798704"/>
          <a:ext cx="2805893" cy="2405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605CE224-84A9-4F80-B564-63CDC85F54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5026280"/>
              </p:ext>
            </p:extLst>
          </p:nvPr>
        </p:nvGraphicFramePr>
        <p:xfrm>
          <a:off x="4488634" y="3600237"/>
          <a:ext cx="4085439" cy="2802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12E8854-7DFF-458C-9393-572D2BA797BC}"/>
              </a:ext>
            </a:extLst>
          </p:cNvPr>
          <p:cNvSpPr txBox="1"/>
          <p:nvPr/>
        </p:nvSpPr>
        <p:spPr>
          <a:xfrm>
            <a:off x="3685763" y="787417"/>
            <a:ext cx="2000250" cy="438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Marriage Status</a:t>
            </a:r>
          </a:p>
          <a:p>
            <a:pPr algn="ctr"/>
            <a:r>
              <a:rPr lang="en-US" altLang="ja-JP" sz="1050" b="1" dirty="0"/>
              <a:t>(n=1236)</a:t>
            </a:r>
            <a:endParaRPr lang="ja-JP" altLang="en-US" sz="1200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E188147-248A-45C3-8AB7-221115BB96A2}"/>
              </a:ext>
            </a:extLst>
          </p:cNvPr>
          <p:cNvSpPr txBox="1"/>
          <p:nvPr/>
        </p:nvSpPr>
        <p:spPr>
          <a:xfrm>
            <a:off x="6472228" y="855849"/>
            <a:ext cx="2000250" cy="438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Children or not</a:t>
            </a:r>
          </a:p>
          <a:p>
            <a:pPr algn="ctr"/>
            <a:r>
              <a:rPr lang="en-US" altLang="ja-JP" sz="1050" b="1" dirty="0"/>
              <a:t>(n=1236)</a:t>
            </a:r>
            <a:endParaRPr lang="ja-JP" altLang="en-US" sz="1200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9CDBEDF-1972-465C-A980-ED4AA2ECD25A}"/>
              </a:ext>
            </a:extLst>
          </p:cNvPr>
          <p:cNvSpPr txBox="1"/>
          <p:nvPr/>
        </p:nvSpPr>
        <p:spPr>
          <a:xfrm>
            <a:off x="1267023" y="3676959"/>
            <a:ext cx="2000250" cy="438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Occupation</a:t>
            </a:r>
          </a:p>
          <a:p>
            <a:pPr algn="ctr"/>
            <a:r>
              <a:rPr lang="en-US" altLang="ja-JP" sz="1050" b="1" dirty="0"/>
              <a:t>(n=1236)</a:t>
            </a:r>
            <a:endParaRPr lang="ja-JP" altLang="en-US" sz="1200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E826628-8ABF-4D05-8984-CD3D3B0E767C}"/>
              </a:ext>
            </a:extLst>
          </p:cNvPr>
          <p:cNvSpPr txBox="1"/>
          <p:nvPr/>
        </p:nvSpPr>
        <p:spPr>
          <a:xfrm>
            <a:off x="5516160" y="3608520"/>
            <a:ext cx="2000250" cy="438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Household Income</a:t>
            </a:r>
          </a:p>
          <a:p>
            <a:pPr algn="ctr"/>
            <a:r>
              <a:rPr lang="en-US" altLang="ja-JP" sz="1050" b="1" dirty="0"/>
              <a:t>(n=1236)</a:t>
            </a:r>
            <a:endParaRPr lang="ja-JP" altLang="en-US" sz="12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BBE7B1-497B-E222-02AD-AD477BF2E0AB}"/>
              </a:ext>
            </a:extLst>
          </p:cNvPr>
          <p:cNvSpPr txBox="1"/>
          <p:nvPr/>
        </p:nvSpPr>
        <p:spPr>
          <a:xfrm>
            <a:off x="2052033" y="71836"/>
            <a:ext cx="54878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2000" b="1" dirty="0">
                <a:effectLst/>
                <a:latin typeface="Calibri" panose="020F0502020204030204" pitchFamily="34" charset="0"/>
                <a:ea typeface="Century" panose="02040604050505020304" pitchFamily="18" charset="0"/>
                <a:cs typeface="Calibri" panose="020F0502020204030204" pitchFamily="34" charset="0"/>
              </a:rPr>
              <a:t>The background characteristics of the participants</a:t>
            </a:r>
            <a:endParaRPr kumimoji="1" lang="ja-JP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266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234</Words>
  <Application>Microsoft Office PowerPoint</Application>
  <PresentationFormat>画面に合わせる (4:3)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赤羽 たけみ</dc:creator>
  <cp:lastModifiedBy>赤羽 たけみ</cp:lastModifiedBy>
  <cp:revision>7</cp:revision>
  <dcterms:created xsi:type="dcterms:W3CDTF">2021-10-19T05:59:21Z</dcterms:created>
  <dcterms:modified xsi:type="dcterms:W3CDTF">2022-10-29T08:46:14Z</dcterms:modified>
</cp:coreProperties>
</file>